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2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9144000" cy="6858000"/>
  <p:notesSz cx="7772400" cy="100584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7772400" cy="100584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sldImg"/>
          </p:nvPr>
        </p:nvSpPr>
        <p:spPr>
          <a:xfrm>
            <a:off x="1371600" y="763200"/>
            <a:ext cx="5027760" cy="3770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>
              <a:lnSpc>
                <a:spcPct val="92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body"/>
          </p:nvPr>
        </p:nvSpPr>
        <p:spPr>
          <a:xfrm>
            <a:off x="777960" y="4776840"/>
            <a:ext cx="6216480" cy="4524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hdr"/>
          </p:nvPr>
        </p:nvSpPr>
        <p:spPr>
          <a:xfrm>
            <a:off x="0" y="-360"/>
            <a:ext cx="3371760" cy="501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lnSpc>
                <a:spcPct val="93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dt" idx="3"/>
          </p:nvPr>
        </p:nvSpPr>
        <p:spPr>
          <a:xfrm>
            <a:off x="4398480" y="-360"/>
            <a:ext cx="3372120" cy="501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lnSpc>
                <a:spcPct val="93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4"/>
          </p:nvPr>
        </p:nvSpPr>
        <p:spPr>
          <a:xfrm>
            <a:off x="0" y="9555120"/>
            <a:ext cx="3371760" cy="501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b">
            <a:noAutofit/>
          </a:bodyPr>
          <a:p>
            <a:pPr indent="0">
              <a:lnSpc>
                <a:spcPct val="93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5"/>
          </p:nvPr>
        </p:nvSpPr>
        <p:spPr>
          <a:xfrm>
            <a:off x="4398480" y="9555120"/>
            <a:ext cx="3372120" cy="501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b">
            <a:noAutofit/>
          </a:bodyPr>
          <a:lstStyle>
            <a:lvl1pPr indent="0" algn="r">
              <a:lnSpc>
                <a:spcPct val="95000"/>
              </a:lnSpc>
              <a:buNone/>
              <a:tabLst>
                <a:tab algn="l" pos="0"/>
                <a:tab algn="l" pos="723960"/>
                <a:tab algn="l" pos="1447920"/>
                <a:tab algn="l" pos="2171880"/>
                <a:tab algn="l" pos="289548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  <a:ea typeface="Arial Unicode MS"/>
              </a:defRPr>
            </a:lvl1pPr>
          </a:lstStyle>
          <a:p>
            <a:pPr indent="0" algn="r">
              <a:lnSpc>
                <a:spcPct val="95000"/>
              </a:lnSpc>
              <a:buNone/>
              <a:tabLst>
                <a:tab algn="l" pos="0"/>
                <a:tab algn="l" pos="723960"/>
                <a:tab algn="l" pos="1447920"/>
                <a:tab algn="l" pos="2171880"/>
                <a:tab algn="l" pos="289548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fld id="{208BC65E-4140-4C87-99EA-90671E7B7BA4}" type="slidenum">
              <a:rPr b="0" lang="en-US" sz="1400" spc="-1" strike="noStrike">
                <a:solidFill>
                  <a:srgbClr val="000000"/>
                </a:solidFill>
                <a:latin typeface="Times New Roman"/>
                <a:ea typeface="Arial Unicode MS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4" name="Rectangle 6"/>
          <p:cNvSpPr/>
          <p:nvPr/>
        </p:nvSpPr>
        <p:spPr>
          <a:xfrm>
            <a:off x="4398840" y="9555120"/>
            <a:ext cx="3372120" cy="501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b">
            <a:noAutofit/>
          </a:bodyPr>
          <a:p>
            <a:pPr algn="r">
              <a:lnSpc>
                <a:spcPct val="95000"/>
              </a:lnSpc>
              <a:tabLst>
                <a:tab algn="l" pos="0"/>
                <a:tab algn="l" pos="723960"/>
                <a:tab algn="l" pos="1447920"/>
                <a:tab algn="l" pos="2171880"/>
                <a:tab algn="l" pos="289548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fld id="{F5D47B99-B034-4708-85DC-E97596FDE754}" type="slidenum">
              <a:rPr b="0" lang="en-US" sz="1400" spc="-1" strike="noStrike">
                <a:solidFill>
                  <a:srgbClr val="000000"/>
                </a:solidFill>
                <a:latin typeface="Times New Roman"/>
                <a:ea typeface="Arial Unicode MS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PlaceHolder 1"/>
          <p:cNvSpPr>
            <a:spLocks noGrp="1"/>
          </p:cNvSpPr>
          <p:nvPr>
            <p:ph type="sldImg"/>
          </p:nvPr>
        </p:nvSpPr>
        <p:spPr>
          <a:xfrm>
            <a:off x="1371600" y="763560"/>
            <a:ext cx="5029200" cy="3772080"/>
          </a:xfrm>
          <a:prstGeom prst="rect">
            <a:avLst/>
          </a:prstGeom>
          <a:ln w="0">
            <a:noFill/>
          </a:ln>
        </p:spPr>
      </p:sp>
      <p:sp>
        <p:nvSpPr>
          <p:cNvPr id="66" name="PlaceHolder 2"/>
          <p:cNvSpPr>
            <a:spLocks noGrp="1"/>
          </p:cNvSpPr>
          <p:nvPr>
            <p:ph type="body"/>
          </p:nvPr>
        </p:nvSpPr>
        <p:spPr>
          <a:xfrm>
            <a:off x="777600" y="4776840"/>
            <a:ext cx="621828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4003A132-BA80-4EB3-95B9-CD465DB10C2D}" type="slidenum">
              <a:t>&lt;#&gt;</a:t>
            </a:fld>
          </a:p>
        </p:txBody>
      </p:sp>
      <p:sp>
        <p:nvSpPr>
          <p:cNvPr id="3" name="PlaceHolder 2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2520"/>
            <a:ext cx="8228160" cy="1143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lnSpc>
                <a:spcPct val="9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4880"/>
            <a:ext cx="8228160" cy="215784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8280"/>
            <a:ext cx="8228160" cy="215784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C15D6B91-0EEE-4420-9615-5288BE5514C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2520"/>
            <a:ext cx="8228160" cy="1143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lnSpc>
                <a:spcPct val="9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4880"/>
            <a:ext cx="4015080" cy="215784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3520" y="1604880"/>
            <a:ext cx="4015080" cy="215784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8280"/>
            <a:ext cx="4015080" cy="215784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3520" y="3968280"/>
            <a:ext cx="4015080" cy="215784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3C84E09F-C213-4592-A150-C1A4FE4C127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2520"/>
            <a:ext cx="8228160" cy="1143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lnSpc>
                <a:spcPct val="9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4880"/>
            <a:ext cx="2649240" cy="215784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280" y="1604880"/>
            <a:ext cx="2649240" cy="215784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1360" y="1604880"/>
            <a:ext cx="2649240" cy="215784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8280"/>
            <a:ext cx="2649240" cy="215784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280" y="3968280"/>
            <a:ext cx="2649240" cy="215784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1360" y="3968280"/>
            <a:ext cx="2649240" cy="215784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A77883FC-15FD-4FBA-A586-748B0B885309}" type="slidenum">
              <a:t>&lt;#&gt;</a:t>
            </a:fld>
          </a:p>
        </p:txBody>
      </p:sp>
      <p:sp>
        <p:nvSpPr>
          <p:cNvPr id="10" name="PlaceHolder 9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2520"/>
            <a:ext cx="8228160" cy="1143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lnSpc>
                <a:spcPct val="9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4880"/>
            <a:ext cx="8228160" cy="4524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383A892C-CBA5-4C6B-9FF5-CF78A73350C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2520"/>
            <a:ext cx="8228160" cy="1143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lnSpc>
                <a:spcPct val="9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4880"/>
            <a:ext cx="8228160" cy="452448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748C73E6-5855-4C21-8DE2-3D604EA5524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2520"/>
            <a:ext cx="8228160" cy="1143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lnSpc>
                <a:spcPct val="9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4880"/>
            <a:ext cx="4015080" cy="452448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3520" y="1604880"/>
            <a:ext cx="4015080" cy="452448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F316CE7A-38D2-4B40-A707-9A5056B4626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2520"/>
            <a:ext cx="8228160" cy="1143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lnSpc>
                <a:spcPct val="9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18CA5A32-6B02-4E67-81A1-2FC46C2AC5FC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2520"/>
            <a:ext cx="822816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2000"/>
              </a:lnSpc>
              <a:spcAft>
                <a:spcPts val="1426"/>
              </a:spcAft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EB1DC9A2-0160-4C00-9E16-53D8E8A0BABC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2520"/>
            <a:ext cx="8228160" cy="1143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lnSpc>
                <a:spcPct val="9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4880"/>
            <a:ext cx="4015080" cy="215784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3520" y="1604880"/>
            <a:ext cx="4015080" cy="452448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8280"/>
            <a:ext cx="4015080" cy="215784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A4C666B5-845F-4799-950D-53108E9B48C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2520"/>
            <a:ext cx="8228160" cy="1143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lnSpc>
                <a:spcPct val="9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4880"/>
            <a:ext cx="4015080" cy="452448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3520" y="1604880"/>
            <a:ext cx="4015080" cy="215784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3520" y="3968280"/>
            <a:ext cx="4015080" cy="215784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1B78C933-0DF5-4C26-B180-F66E9BAC469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2520"/>
            <a:ext cx="8228160" cy="1143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lnSpc>
                <a:spcPct val="9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4880"/>
            <a:ext cx="4015080" cy="215784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3520" y="1604880"/>
            <a:ext cx="4015080" cy="215784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8280"/>
            <a:ext cx="8228160" cy="215784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22BA9E2B-A3ED-42C8-9709-D6CFE880F27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dt" idx="1"/>
          </p:nvPr>
        </p:nvSpPr>
        <p:spPr>
          <a:xfrm>
            <a:off x="628200" y="6356160"/>
            <a:ext cx="2055960" cy="363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t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723960"/>
                <a:tab algn="l" pos="144792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  <a:defRPr b="0" lang="en-US" sz="1800" spc="-1" strike="noStrike">
                <a:solidFill>
                  <a:srgbClr val="000000"/>
                </a:solidFill>
                <a:latin typeface="Calibri"/>
                <a:ea typeface="Arial Unicode MS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723960"/>
                <a:tab algn="l" pos="144792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  <a:ea typeface="Arial Unicode MS"/>
              </a:rPr>
              <a:t>6/2/18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Text Box 2"/>
          <p:cNvSpPr/>
          <p:nvPr/>
        </p:nvSpPr>
        <p:spPr>
          <a:xfrm>
            <a:off x="3029040" y="6356520"/>
            <a:ext cx="3085920" cy="365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2"/>
          <p:cNvSpPr>
            <a:spLocks noGrp="1"/>
          </p:cNvSpPr>
          <p:nvPr>
            <p:ph type="sldNum" idx="2"/>
          </p:nvPr>
        </p:nvSpPr>
        <p:spPr>
          <a:xfrm>
            <a:off x="6458040" y="6356160"/>
            <a:ext cx="2055600" cy="363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t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723960"/>
                <a:tab algn="l" pos="144792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  <a:defRPr b="0" lang="en-US" sz="1800" spc="-1" strike="noStrike">
                <a:solidFill>
                  <a:srgbClr val="000000"/>
                </a:solidFill>
                <a:latin typeface="Calibri"/>
                <a:ea typeface="Arial Unicode MS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723960"/>
                <a:tab algn="l" pos="144792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fld id="{E8ABD440-2D05-4212-A39D-E4C916323D99}" type="slidenum">
              <a:rPr b="0" lang="en-US" sz="1800" spc="-1" strike="noStrike">
                <a:solidFill>
                  <a:srgbClr val="000000"/>
                </a:solidFill>
                <a:latin typeface="Calibri"/>
                <a:ea typeface="Arial Unicode MS"/>
              </a:rPr>
              <a:t>&lt;number&gt;</a:t>
            </a:fld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3"/>
          <p:cNvSpPr>
            <a:spLocks noGrp="1"/>
          </p:cNvSpPr>
          <p:nvPr>
            <p:ph type="title"/>
          </p:nvPr>
        </p:nvSpPr>
        <p:spPr>
          <a:xfrm>
            <a:off x="457200" y="272520"/>
            <a:ext cx="8228160" cy="1143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lnSpc>
                <a:spcPct val="9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4"/>
          <p:cNvSpPr>
            <a:spLocks noGrp="1"/>
          </p:cNvSpPr>
          <p:nvPr>
            <p:ph type="body"/>
          </p:nvPr>
        </p:nvSpPr>
        <p:spPr>
          <a:xfrm>
            <a:off x="457200" y="1604880"/>
            <a:ext cx="8228160" cy="452448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1" marL="343080" indent="-343080">
              <a:lnSpc>
                <a:spcPct val="92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–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2" marL="343080" indent="-343080">
              <a:lnSpc>
                <a:spcPct val="92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•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3" marL="343080" indent="-343080">
              <a:lnSpc>
                <a:spcPct val="92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–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4" marL="343080" indent="-343080">
              <a:lnSpc>
                <a:spcPct val="92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5" marL="343080" indent="-343080">
              <a:lnSpc>
                <a:spcPct val="92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6" marL="343080" indent="-343080">
              <a:lnSpc>
                <a:spcPct val="92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png"/><Relationship Id="rId3" Type="http://schemas.openxmlformats.org/officeDocument/2006/relationships/slideLayout" Target="../slideLayouts/slideLayout1.xml"/><Relationship Id="rId4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8" name="Group 1"/>
          <p:cNvGrpSpPr/>
          <p:nvPr/>
        </p:nvGrpSpPr>
        <p:grpSpPr>
          <a:xfrm>
            <a:off x="1060560" y="1469880"/>
            <a:ext cx="6931080" cy="2959200"/>
            <a:chOff x="1060560" y="1469880"/>
            <a:chExt cx="6931080" cy="2959200"/>
          </a:xfrm>
        </p:grpSpPr>
        <p:pic>
          <p:nvPicPr>
            <p:cNvPr id="49" name="Picture 2" descr=""/>
            <p:cNvPicPr/>
            <p:nvPr/>
          </p:nvPicPr>
          <p:blipFill>
            <a:blip r:embed="rId1"/>
            <a:srcRect l="0" t="11731" r="0" b="0"/>
            <a:stretch/>
          </p:blipFill>
          <p:spPr>
            <a:xfrm>
              <a:off x="1060560" y="1469880"/>
              <a:ext cx="6931080" cy="29592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0" name="Rectangle 3"/>
            <p:cNvSpPr/>
            <p:nvPr/>
          </p:nvSpPr>
          <p:spPr>
            <a:xfrm>
              <a:off x="5204880" y="3753000"/>
              <a:ext cx="1463760" cy="333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5000" bIns="450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723960"/>
                  <a:tab algn="l" pos="144792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  <a:tab algn="l" pos="9601200"/>
                  <a:tab algn="l" pos="10058400"/>
                  <a:tab algn="l" pos="10515600"/>
                </a:tabLst>
              </a:pPr>
              <a:r>
                <a:rPr b="1" lang="en-US" sz="1600" spc="-1" strike="noStrike">
                  <a:solidFill>
                    <a:srgbClr val="0000ff"/>
                  </a:solidFill>
                  <a:latin typeface="Arial"/>
                </a:rPr>
                <a:t>Empty vector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Rectangle 4"/>
            <p:cNvSpPr/>
            <p:nvPr/>
          </p:nvSpPr>
          <p:spPr>
            <a:xfrm>
              <a:off x="5206320" y="3359160"/>
              <a:ext cx="1700280" cy="333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5000" bIns="450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723960"/>
                  <a:tab algn="l" pos="144792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  <a:tab algn="l" pos="9601200"/>
                  <a:tab algn="l" pos="10058400"/>
                  <a:tab algn="l" pos="10515600"/>
                </a:tabLst>
              </a:pPr>
              <a:r>
                <a:rPr b="1" lang="en-US" sz="1600" spc="-1" strike="noStrike">
                  <a:solidFill>
                    <a:srgbClr val="ff0000"/>
                  </a:solidFill>
                  <a:latin typeface="Arial"/>
                </a:rPr>
                <a:t>MPIsp3 product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Rectangle 5"/>
            <p:cNvSpPr/>
            <p:nvPr/>
          </p:nvSpPr>
          <p:spPr>
            <a:xfrm>
              <a:off x="5202000" y="2965320"/>
              <a:ext cx="1024920" cy="333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5000" bIns="450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72396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  <a:tab algn="l" pos="9601200"/>
                </a:tabLst>
              </a:pPr>
              <a:r>
                <a:rPr b="1" lang="en-US" sz="1600" spc="-1" strike="noStrike">
                  <a:solidFill>
                    <a:srgbClr val="007434"/>
                  </a:solidFill>
                  <a:latin typeface="Arial"/>
                </a:rPr>
                <a:t>Isoprene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cxnSp>
          <p:nvCxnSpPr>
            <p:cNvPr id="53" name="AutoShape 6"/>
            <p:cNvCxnSpPr/>
            <p:nvPr/>
          </p:nvCxnSpPr>
          <p:spPr>
            <a:xfrm flipV="1" rot="10800000">
              <a:off x="4799880" y="3526560"/>
              <a:ext cx="392760" cy="65520"/>
            </a:xfrm>
            <a:prstGeom prst="bentConnector3">
              <a:avLst>
                <a:gd name="adj1" fmla="val 50000"/>
              </a:avLst>
            </a:prstGeom>
            <a:ln w="6480">
              <a:solidFill>
                <a:srgbClr val="ff0000"/>
              </a:solidFill>
              <a:miter/>
              <a:tailEnd len="med" type="triangle" w="med"/>
            </a:ln>
          </p:spPr>
        </p:cxnSp>
        <p:cxnSp>
          <p:nvCxnSpPr>
            <p:cNvPr id="54" name="AutoShape 7"/>
            <p:cNvCxnSpPr/>
            <p:nvPr/>
          </p:nvCxnSpPr>
          <p:spPr>
            <a:xfrm rot="10800000">
              <a:off x="4866480" y="2874240"/>
              <a:ext cx="327960" cy="246960"/>
            </a:xfrm>
            <a:prstGeom prst="bentConnector3">
              <a:avLst>
                <a:gd name="adj1" fmla="val 50000"/>
              </a:avLst>
            </a:prstGeom>
            <a:ln w="6480">
              <a:solidFill>
                <a:srgbClr val="007434"/>
              </a:solidFill>
              <a:miter/>
              <a:tailEnd len="med" type="triangle" w="med"/>
            </a:ln>
          </p:spPr>
        </p:cxnSp>
        <p:cxnSp>
          <p:nvCxnSpPr>
            <p:cNvPr id="55" name="AutoShape 8"/>
            <p:cNvCxnSpPr/>
            <p:nvPr/>
          </p:nvCxnSpPr>
          <p:spPr>
            <a:xfrm flipV="1" rot="10800000">
              <a:off x="4799880" y="3903480"/>
              <a:ext cx="392760" cy="84600"/>
            </a:xfrm>
            <a:prstGeom prst="bentConnector3">
              <a:avLst>
                <a:gd name="adj1" fmla="val 50000"/>
              </a:avLst>
            </a:prstGeom>
            <a:ln w="6480">
              <a:solidFill>
                <a:srgbClr val="0000ff"/>
              </a:solidFill>
              <a:miter/>
              <a:tailEnd len="med" type="triangle" w="med"/>
            </a:ln>
          </p:spPr>
        </p:cxnSp>
      </p:grpSp>
      <p:sp>
        <p:nvSpPr>
          <p:cNvPr id="56" name="Rectangle 9"/>
          <p:cNvSpPr/>
          <p:nvPr/>
        </p:nvSpPr>
        <p:spPr>
          <a:xfrm>
            <a:off x="181080" y="5486400"/>
            <a:ext cx="8690040" cy="942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723960"/>
                <a:tab algn="l" pos="1447920"/>
                <a:tab algn="l" pos="2171880"/>
                <a:tab algn="l" pos="2895480"/>
                <a:tab algn="l" pos="3619440"/>
                <a:tab algn="l" pos="4343400"/>
                <a:tab algn="l" pos="5067360"/>
                <a:tab algn="l" pos="5791320"/>
                <a:tab algn="l" pos="6515280"/>
                <a:tab algn="l" pos="7238880"/>
                <a:tab algn="l" pos="796284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Fig. S2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. GC-MS analysis of isoprene from the head space in culture for MPIspS3 and MVA pathway harboring </a:t>
            </a:r>
            <a:r>
              <a:rPr b="0" i="1" lang="en-US" sz="1400" spc="-1" strike="noStrike">
                <a:solidFill>
                  <a:srgbClr val="000000"/>
                </a:solidFill>
                <a:latin typeface="Arial"/>
              </a:rPr>
              <a:t>E. coli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. Isoprene, MPIspS3 product, and empty vector represent commercial isoprene as standard, product from MPIspS3 and MVA pathway harboring </a:t>
            </a:r>
            <a:r>
              <a:rPr b="0" i="1" lang="en-US" sz="1400" spc="-1" strike="noStrike">
                <a:solidFill>
                  <a:srgbClr val="000000"/>
                </a:solidFill>
                <a:latin typeface="Arial"/>
              </a:rPr>
              <a:t>E. coli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, and</a:t>
            </a:r>
            <a:r>
              <a:rPr b="0" i="1" lang="en-US" sz="14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product from pET28a(+) and MVA pathway harboring </a:t>
            </a:r>
            <a:r>
              <a:rPr b="0" i="1" lang="en-US" sz="1400" spc="-1" strike="noStrike">
                <a:solidFill>
                  <a:srgbClr val="000000"/>
                </a:solidFill>
                <a:latin typeface="Arial"/>
              </a:rPr>
              <a:t>E. coli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, respectively.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57" name="Group 10"/>
          <p:cNvGrpSpPr/>
          <p:nvPr/>
        </p:nvGrpSpPr>
        <p:grpSpPr>
          <a:xfrm>
            <a:off x="1684080" y="914400"/>
            <a:ext cx="1992240" cy="1413000"/>
            <a:chOff x="1684080" y="914400"/>
            <a:chExt cx="1992240" cy="1413000"/>
          </a:xfrm>
        </p:grpSpPr>
        <p:pic>
          <p:nvPicPr>
            <p:cNvPr id="58" name="Picture 11" descr=""/>
            <p:cNvPicPr/>
            <p:nvPr/>
          </p:nvPicPr>
          <p:blipFill>
            <a:blip r:embed="rId2"/>
            <a:stretch/>
          </p:blipFill>
          <p:spPr>
            <a:xfrm>
              <a:off x="1700280" y="914400"/>
              <a:ext cx="1692360" cy="1413000"/>
            </a:xfrm>
            <a:prstGeom prst="rect">
              <a:avLst/>
            </a:prstGeom>
            <a:ln w="0">
              <a:noFill/>
            </a:ln>
          </p:spPr>
        </p:pic>
        <p:grpSp>
          <p:nvGrpSpPr>
            <p:cNvPr id="59" name="Group 12"/>
            <p:cNvGrpSpPr/>
            <p:nvPr/>
          </p:nvGrpSpPr>
          <p:grpSpPr>
            <a:xfrm>
              <a:off x="1684080" y="1000080"/>
              <a:ext cx="1992240" cy="927360"/>
              <a:chOff x="1684080" y="1000080"/>
              <a:chExt cx="1992240" cy="927360"/>
            </a:xfrm>
          </p:grpSpPr>
          <p:cxnSp>
            <p:nvCxnSpPr>
              <p:cNvPr id="60" name="AutoShape 13"/>
              <p:cNvCxnSpPr/>
              <p:nvPr/>
            </p:nvCxnSpPr>
            <p:spPr>
              <a:xfrm flipV="1" rot="10800000">
                <a:off x="2602800" y="1329840"/>
                <a:ext cx="321480" cy="349920"/>
              </a:xfrm>
              <a:prstGeom prst="bentConnector3">
                <a:avLst>
                  <a:gd name="adj1" fmla="val 50000"/>
                </a:avLst>
              </a:prstGeom>
              <a:ln w="6480">
                <a:solidFill>
                  <a:srgbClr val="000000"/>
                </a:solidFill>
                <a:miter/>
                <a:tailEnd len="med" type="triangle" w="med"/>
              </a:ln>
            </p:spPr>
          </p:cxnSp>
          <p:sp>
            <p:nvSpPr>
              <p:cNvPr id="61" name="Rectangle 14"/>
              <p:cNvSpPr/>
              <p:nvPr/>
            </p:nvSpPr>
            <p:spPr>
              <a:xfrm>
                <a:off x="2706120" y="1060560"/>
                <a:ext cx="970200" cy="3337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5000" bIns="450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72396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  <a:tab algn="l" pos="9601200"/>
                  </a:tabLst>
                </a:pPr>
                <a:r>
                  <a:rPr b="0" lang="en-US" sz="1600" spc="-1" strike="noStrike">
                    <a:solidFill>
                      <a:srgbClr val="000000"/>
                    </a:solidFill>
                    <a:latin typeface="Arial"/>
                  </a:rPr>
                  <a:t>Isoprene</a:t>
                </a:r>
                <a:endParaRPr b="0" lang="en-US" sz="1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2" name="Rectangle 15"/>
              <p:cNvSpPr/>
              <p:nvPr/>
            </p:nvSpPr>
            <p:spPr>
              <a:xfrm>
                <a:off x="1684080" y="1000080"/>
                <a:ext cx="766080" cy="927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5000" bIns="450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72396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  <a:tab algn="l" pos="9601200"/>
                  </a:tabLst>
                </a:pPr>
                <a:r>
                  <a:rPr b="0" lang="en-US" sz="1100" spc="-1" strike="noStrike">
                    <a:solidFill>
                      <a:srgbClr val="000000"/>
                    </a:solidFill>
                    <a:latin typeface="Arial"/>
                  </a:rPr>
                  <a:t>250 mg/L</a:t>
                </a:r>
                <a:endParaRPr b="0" lang="en-US" sz="11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00000"/>
                  </a:lnSpc>
                  <a:tabLst>
                    <a:tab algn="l" pos="0"/>
                    <a:tab algn="l" pos="72396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  <a:tab algn="l" pos="9601200"/>
                  </a:tabLst>
                </a:pPr>
                <a:r>
                  <a:rPr b="0" lang="en-US" sz="1100" spc="-1" strike="noStrike">
                    <a:solidFill>
                      <a:srgbClr val="000000"/>
                    </a:solidFill>
                    <a:latin typeface="Arial"/>
                  </a:rPr>
                  <a:t>200 mg/L</a:t>
                </a:r>
                <a:endParaRPr b="0" lang="en-US" sz="11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00000"/>
                  </a:lnSpc>
                  <a:tabLst>
                    <a:tab algn="l" pos="0"/>
                    <a:tab algn="l" pos="72396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  <a:tab algn="l" pos="9601200"/>
                  </a:tabLst>
                </a:pPr>
                <a:r>
                  <a:rPr b="0" lang="en-US" sz="1100" spc="-1" strike="noStrike">
                    <a:solidFill>
                      <a:srgbClr val="000000"/>
                    </a:solidFill>
                    <a:latin typeface="Arial"/>
                  </a:rPr>
                  <a:t>150 mg/L</a:t>
                </a:r>
                <a:endParaRPr b="0" lang="en-US" sz="11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00000"/>
                  </a:lnSpc>
                  <a:tabLst>
                    <a:tab algn="l" pos="0"/>
                    <a:tab algn="l" pos="72396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  <a:tab algn="l" pos="9601200"/>
                  </a:tabLst>
                </a:pPr>
                <a:r>
                  <a:rPr b="0" lang="en-US" sz="1100" spc="-1" strike="noStrike">
                    <a:solidFill>
                      <a:srgbClr val="000000"/>
                    </a:solidFill>
                    <a:latin typeface="Arial"/>
                  </a:rPr>
                  <a:t>100 mg/L</a:t>
                </a:r>
                <a:endParaRPr b="0" lang="en-US" sz="11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00000"/>
                  </a:lnSpc>
                  <a:tabLst>
                    <a:tab algn="l" pos="0"/>
                    <a:tab algn="l" pos="72396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  <a:tab algn="l" pos="9601200"/>
                  </a:tabLst>
                </a:pPr>
                <a:r>
                  <a:rPr b="0" lang="en-US" sz="1100" spc="-1" strike="noStrike">
                    <a:solidFill>
                      <a:srgbClr val="000000"/>
                    </a:solidFill>
                    <a:latin typeface="Arial"/>
                  </a:rPr>
                  <a:t>75 mg/L</a:t>
                </a:r>
                <a:endParaRPr b="0" lang="en-US" sz="11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  <p:sp>
        <p:nvSpPr>
          <p:cNvPr id="63" name="Rectangle 16"/>
          <p:cNvSpPr/>
          <p:nvPr/>
        </p:nvSpPr>
        <p:spPr>
          <a:xfrm>
            <a:off x="4346640" y="1270080"/>
            <a:ext cx="819000" cy="30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72396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2.8min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creator/>
  <dc:description/>
  <dc:language>en-US</dc:language>
  <cp:lastModifiedBy>Jerrick  Rivas</cp:lastModifiedBy>
  <dcterms:modified xsi:type="dcterms:W3CDTF">2018-06-13T05:56:16Z</dcterms:modified>
  <cp:revision>1</cp:revision>
  <dc:subject/>
  <dc:title>PowerPoint Presentation</dc:title>
</cp:coreProperties>
</file>